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119813" cy="8459788"/>
  <p:notesSz cx="6796088" cy="98742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E7119E-6F84-4EDC-BF09-2C549030C18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8280" y="752400"/>
            <a:ext cx="5203800" cy="1409760"/>
          </a:xfrm>
          <a:prstGeom prst="rect">
            <a:avLst/>
          </a:prstGeom>
          <a:noFill/>
          <a:ln w="0">
            <a:noFill/>
          </a:ln>
        </p:spPr>
        <p:txBody>
          <a:bodyPr lIns="78480" rIns="78480" tIns="39240" bIns="39240" anchor="ctr">
            <a:noAutofit/>
          </a:bodyPr>
          <a:p>
            <a:pPr indent="0" algn="ctr">
              <a:buNone/>
              <a:tabLst>
                <a:tab algn="l" pos="0"/>
                <a:tab algn="l" pos="785880"/>
                <a:tab algn="l" pos="1571760"/>
                <a:tab algn="l" pos="2357280"/>
                <a:tab algn="l" pos="3143160"/>
                <a:tab algn="l" pos="3929040"/>
                <a:tab algn="l" pos="4714920"/>
                <a:tab algn="l" pos="5500800"/>
                <a:tab algn="l" pos="6286680"/>
                <a:tab algn="l" pos="7072200"/>
                <a:tab algn="l" pos="7858080"/>
                <a:tab algn="l" pos="8643960"/>
                <a:tab algn="l" pos="9429840"/>
                <a:tab algn="l" pos="10215720"/>
              </a:tabLst>
            </a:pPr>
            <a:endParaRPr b="0" lang="en-US" sz="3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8280" y="2444760"/>
            <a:ext cx="5203800" cy="2421360"/>
          </a:xfrm>
          <a:prstGeom prst="rect">
            <a:avLst/>
          </a:prstGeom>
          <a:noFill/>
          <a:ln w="0">
            <a:noFill/>
          </a:ln>
        </p:spPr>
        <p:txBody>
          <a:bodyPr lIns="78480" rIns="78480" tIns="39240" bIns="3924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785880"/>
                <a:tab algn="l" pos="1571760"/>
                <a:tab algn="l" pos="2357280"/>
                <a:tab algn="l" pos="3143160"/>
                <a:tab algn="l" pos="3929040"/>
                <a:tab algn="l" pos="4714920"/>
                <a:tab algn="l" pos="5500800"/>
                <a:tab algn="l" pos="6286680"/>
                <a:tab algn="l" pos="7072200"/>
                <a:tab algn="l" pos="7858080"/>
                <a:tab algn="l" pos="8643960"/>
                <a:tab algn="l" pos="9429840"/>
                <a:tab algn="l" pos="10215720"/>
              </a:tabLst>
            </a:pPr>
            <a:endParaRPr b="0" lang="en-US" sz="2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8280" y="5096520"/>
            <a:ext cx="5203800" cy="2421360"/>
          </a:xfrm>
          <a:prstGeom prst="rect">
            <a:avLst/>
          </a:prstGeom>
          <a:noFill/>
          <a:ln w="0">
            <a:noFill/>
          </a:ln>
        </p:spPr>
        <p:txBody>
          <a:bodyPr lIns="78480" rIns="78480" tIns="39240" bIns="3924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785880"/>
                <a:tab algn="l" pos="1571760"/>
                <a:tab algn="l" pos="2357280"/>
                <a:tab algn="l" pos="3143160"/>
                <a:tab algn="l" pos="3929040"/>
                <a:tab algn="l" pos="4714920"/>
                <a:tab algn="l" pos="5500800"/>
                <a:tab algn="l" pos="6286680"/>
                <a:tab algn="l" pos="7072200"/>
                <a:tab algn="l" pos="7858080"/>
                <a:tab algn="l" pos="8643960"/>
                <a:tab algn="l" pos="9429840"/>
                <a:tab algn="l" pos="10215720"/>
              </a:tabLst>
            </a:pPr>
            <a:endParaRPr b="0" lang="en-US" sz="2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A0CD15-B5F4-4A18-8518-CEFA6B12C3F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8280" y="752400"/>
            <a:ext cx="5203800" cy="1409760"/>
          </a:xfrm>
          <a:prstGeom prst="rect">
            <a:avLst/>
          </a:prstGeom>
          <a:noFill/>
          <a:ln w="0">
            <a:noFill/>
          </a:ln>
        </p:spPr>
        <p:txBody>
          <a:bodyPr lIns="78480" rIns="78480" tIns="39240" bIns="39240" anchor="ctr">
            <a:noAutofit/>
          </a:bodyPr>
          <a:p>
            <a:pPr indent="0" algn="ctr">
              <a:buNone/>
              <a:tabLst>
                <a:tab algn="l" pos="0"/>
                <a:tab algn="l" pos="785880"/>
                <a:tab algn="l" pos="1571760"/>
                <a:tab algn="l" pos="2357280"/>
                <a:tab algn="l" pos="3143160"/>
                <a:tab algn="l" pos="3929040"/>
                <a:tab algn="l" pos="4714920"/>
                <a:tab algn="l" pos="5500800"/>
                <a:tab algn="l" pos="6286680"/>
                <a:tab algn="l" pos="7072200"/>
                <a:tab algn="l" pos="7858080"/>
                <a:tab algn="l" pos="8643960"/>
                <a:tab algn="l" pos="9429840"/>
                <a:tab algn="l" pos="10215720"/>
              </a:tabLst>
            </a:pPr>
            <a:endParaRPr b="0" lang="en-US" sz="3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8280" y="2444760"/>
            <a:ext cx="2539440" cy="2421360"/>
          </a:xfrm>
          <a:prstGeom prst="rect">
            <a:avLst/>
          </a:prstGeom>
          <a:noFill/>
          <a:ln w="0">
            <a:noFill/>
          </a:ln>
        </p:spPr>
        <p:txBody>
          <a:bodyPr lIns="78480" rIns="78480" tIns="39240" bIns="3924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785880"/>
                <a:tab algn="l" pos="1571760"/>
                <a:tab algn="l" pos="2357280"/>
                <a:tab algn="l" pos="3143160"/>
                <a:tab algn="l" pos="3929040"/>
                <a:tab algn="l" pos="4714920"/>
                <a:tab algn="l" pos="5500800"/>
                <a:tab algn="l" pos="6286680"/>
                <a:tab algn="l" pos="7072200"/>
                <a:tab algn="l" pos="7858080"/>
                <a:tab algn="l" pos="8643960"/>
                <a:tab algn="l" pos="9429840"/>
                <a:tab algn="l" pos="10215720"/>
              </a:tabLst>
            </a:pPr>
            <a:endParaRPr b="0" lang="en-US" sz="2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125160" y="2444760"/>
            <a:ext cx="2539440" cy="2421360"/>
          </a:xfrm>
          <a:prstGeom prst="rect">
            <a:avLst/>
          </a:prstGeom>
          <a:noFill/>
          <a:ln w="0">
            <a:noFill/>
          </a:ln>
        </p:spPr>
        <p:txBody>
          <a:bodyPr lIns="78480" rIns="78480" tIns="39240" bIns="3924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785880"/>
                <a:tab algn="l" pos="1571760"/>
                <a:tab algn="l" pos="2357280"/>
                <a:tab algn="l" pos="3143160"/>
                <a:tab algn="l" pos="3929040"/>
                <a:tab algn="l" pos="4714920"/>
                <a:tab algn="l" pos="5500800"/>
                <a:tab algn="l" pos="6286680"/>
                <a:tab algn="l" pos="7072200"/>
                <a:tab algn="l" pos="7858080"/>
                <a:tab algn="l" pos="8643960"/>
                <a:tab algn="l" pos="9429840"/>
                <a:tab algn="l" pos="10215720"/>
              </a:tabLst>
            </a:pPr>
            <a:endParaRPr b="0" lang="en-US" sz="2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8280" y="5096520"/>
            <a:ext cx="2539440" cy="2421360"/>
          </a:xfrm>
          <a:prstGeom prst="rect">
            <a:avLst/>
          </a:prstGeom>
          <a:noFill/>
          <a:ln w="0">
            <a:noFill/>
          </a:ln>
        </p:spPr>
        <p:txBody>
          <a:bodyPr lIns="78480" rIns="78480" tIns="39240" bIns="3924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785880"/>
                <a:tab algn="l" pos="1571760"/>
                <a:tab algn="l" pos="2357280"/>
                <a:tab algn="l" pos="3143160"/>
                <a:tab algn="l" pos="3929040"/>
                <a:tab algn="l" pos="4714920"/>
                <a:tab algn="l" pos="5500800"/>
                <a:tab algn="l" pos="6286680"/>
                <a:tab algn="l" pos="7072200"/>
                <a:tab algn="l" pos="7858080"/>
                <a:tab algn="l" pos="8643960"/>
                <a:tab algn="l" pos="9429840"/>
                <a:tab algn="l" pos="10215720"/>
              </a:tabLst>
            </a:pPr>
            <a:endParaRPr b="0" lang="en-US" sz="2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125160" y="5096520"/>
            <a:ext cx="2539440" cy="2421360"/>
          </a:xfrm>
          <a:prstGeom prst="rect">
            <a:avLst/>
          </a:prstGeom>
          <a:noFill/>
          <a:ln w="0">
            <a:noFill/>
          </a:ln>
        </p:spPr>
        <p:txBody>
          <a:bodyPr lIns="78480" rIns="78480" tIns="39240" bIns="3924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785880"/>
                <a:tab algn="l" pos="1571760"/>
                <a:tab algn="l" pos="2357280"/>
                <a:tab algn="l" pos="3143160"/>
                <a:tab algn="l" pos="3929040"/>
                <a:tab algn="l" pos="4714920"/>
                <a:tab algn="l" pos="5500800"/>
                <a:tab algn="l" pos="6286680"/>
                <a:tab algn="l" pos="7072200"/>
                <a:tab algn="l" pos="7858080"/>
                <a:tab algn="l" pos="8643960"/>
                <a:tab algn="l" pos="9429840"/>
                <a:tab algn="l" pos="10215720"/>
              </a:tabLst>
            </a:pPr>
            <a:endParaRPr b="0" lang="en-US" sz="2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DD69E6-3500-448C-A798-3523F81EC13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8280" y="752400"/>
            <a:ext cx="5203800" cy="1409760"/>
          </a:xfrm>
          <a:prstGeom prst="rect">
            <a:avLst/>
          </a:prstGeom>
          <a:noFill/>
          <a:ln w="0">
            <a:noFill/>
          </a:ln>
        </p:spPr>
        <p:txBody>
          <a:bodyPr lIns="78480" rIns="78480" tIns="39240" bIns="39240" anchor="ctr">
            <a:noAutofit/>
          </a:bodyPr>
          <a:p>
            <a:pPr indent="0" algn="ctr">
              <a:buNone/>
              <a:tabLst>
                <a:tab algn="l" pos="0"/>
                <a:tab algn="l" pos="785880"/>
                <a:tab algn="l" pos="1571760"/>
                <a:tab algn="l" pos="2357280"/>
                <a:tab algn="l" pos="3143160"/>
                <a:tab algn="l" pos="3929040"/>
                <a:tab algn="l" pos="4714920"/>
                <a:tab algn="l" pos="5500800"/>
                <a:tab algn="l" pos="6286680"/>
                <a:tab algn="l" pos="7072200"/>
                <a:tab algn="l" pos="7858080"/>
                <a:tab algn="l" pos="8643960"/>
                <a:tab algn="l" pos="9429840"/>
                <a:tab algn="l" pos="10215720"/>
              </a:tabLst>
            </a:pPr>
            <a:endParaRPr b="0" lang="en-US" sz="3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8280" y="2444760"/>
            <a:ext cx="1675440" cy="2421360"/>
          </a:xfrm>
          <a:prstGeom prst="rect">
            <a:avLst/>
          </a:prstGeom>
          <a:noFill/>
          <a:ln w="0">
            <a:noFill/>
          </a:ln>
        </p:spPr>
        <p:txBody>
          <a:bodyPr lIns="78480" rIns="78480" tIns="39240" bIns="3924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785880"/>
                <a:tab algn="l" pos="1571760"/>
                <a:tab algn="l" pos="2357280"/>
                <a:tab algn="l" pos="3143160"/>
                <a:tab algn="l" pos="3929040"/>
                <a:tab algn="l" pos="4714920"/>
                <a:tab algn="l" pos="5500800"/>
                <a:tab algn="l" pos="6286680"/>
                <a:tab algn="l" pos="7072200"/>
                <a:tab algn="l" pos="7858080"/>
                <a:tab algn="l" pos="8643960"/>
                <a:tab algn="l" pos="9429840"/>
                <a:tab algn="l" pos="10215720"/>
              </a:tabLst>
            </a:pPr>
            <a:endParaRPr b="0" lang="en-US" sz="2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217960" y="2444760"/>
            <a:ext cx="1675440" cy="2421360"/>
          </a:xfrm>
          <a:prstGeom prst="rect">
            <a:avLst/>
          </a:prstGeom>
          <a:noFill/>
          <a:ln w="0">
            <a:noFill/>
          </a:ln>
        </p:spPr>
        <p:txBody>
          <a:bodyPr lIns="78480" rIns="78480" tIns="39240" bIns="3924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785880"/>
                <a:tab algn="l" pos="1571760"/>
                <a:tab algn="l" pos="2357280"/>
                <a:tab algn="l" pos="3143160"/>
                <a:tab algn="l" pos="3929040"/>
                <a:tab algn="l" pos="4714920"/>
                <a:tab algn="l" pos="5500800"/>
                <a:tab algn="l" pos="6286680"/>
                <a:tab algn="l" pos="7072200"/>
                <a:tab algn="l" pos="7858080"/>
                <a:tab algn="l" pos="8643960"/>
                <a:tab algn="l" pos="9429840"/>
                <a:tab algn="l" pos="10215720"/>
              </a:tabLst>
            </a:pPr>
            <a:endParaRPr b="0" lang="en-US" sz="2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3977640" y="2444760"/>
            <a:ext cx="1675440" cy="2421360"/>
          </a:xfrm>
          <a:prstGeom prst="rect">
            <a:avLst/>
          </a:prstGeom>
          <a:noFill/>
          <a:ln w="0">
            <a:noFill/>
          </a:ln>
        </p:spPr>
        <p:txBody>
          <a:bodyPr lIns="78480" rIns="78480" tIns="39240" bIns="3924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785880"/>
                <a:tab algn="l" pos="1571760"/>
                <a:tab algn="l" pos="2357280"/>
                <a:tab algn="l" pos="3143160"/>
                <a:tab algn="l" pos="3929040"/>
                <a:tab algn="l" pos="4714920"/>
                <a:tab algn="l" pos="5500800"/>
                <a:tab algn="l" pos="6286680"/>
                <a:tab algn="l" pos="7072200"/>
                <a:tab algn="l" pos="7858080"/>
                <a:tab algn="l" pos="8643960"/>
                <a:tab algn="l" pos="9429840"/>
                <a:tab algn="l" pos="10215720"/>
              </a:tabLst>
            </a:pPr>
            <a:endParaRPr b="0" lang="en-US" sz="2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8280" y="5096520"/>
            <a:ext cx="1675440" cy="2421360"/>
          </a:xfrm>
          <a:prstGeom prst="rect">
            <a:avLst/>
          </a:prstGeom>
          <a:noFill/>
          <a:ln w="0">
            <a:noFill/>
          </a:ln>
        </p:spPr>
        <p:txBody>
          <a:bodyPr lIns="78480" rIns="78480" tIns="39240" bIns="3924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785880"/>
                <a:tab algn="l" pos="1571760"/>
                <a:tab algn="l" pos="2357280"/>
                <a:tab algn="l" pos="3143160"/>
                <a:tab algn="l" pos="3929040"/>
                <a:tab algn="l" pos="4714920"/>
                <a:tab algn="l" pos="5500800"/>
                <a:tab algn="l" pos="6286680"/>
                <a:tab algn="l" pos="7072200"/>
                <a:tab algn="l" pos="7858080"/>
                <a:tab algn="l" pos="8643960"/>
                <a:tab algn="l" pos="9429840"/>
                <a:tab algn="l" pos="10215720"/>
              </a:tabLst>
            </a:pPr>
            <a:endParaRPr b="0" lang="en-US" sz="2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217960" y="5096520"/>
            <a:ext cx="1675440" cy="2421360"/>
          </a:xfrm>
          <a:prstGeom prst="rect">
            <a:avLst/>
          </a:prstGeom>
          <a:noFill/>
          <a:ln w="0">
            <a:noFill/>
          </a:ln>
        </p:spPr>
        <p:txBody>
          <a:bodyPr lIns="78480" rIns="78480" tIns="39240" bIns="3924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785880"/>
                <a:tab algn="l" pos="1571760"/>
                <a:tab algn="l" pos="2357280"/>
                <a:tab algn="l" pos="3143160"/>
                <a:tab algn="l" pos="3929040"/>
                <a:tab algn="l" pos="4714920"/>
                <a:tab algn="l" pos="5500800"/>
                <a:tab algn="l" pos="6286680"/>
                <a:tab algn="l" pos="7072200"/>
                <a:tab algn="l" pos="7858080"/>
                <a:tab algn="l" pos="8643960"/>
                <a:tab algn="l" pos="9429840"/>
                <a:tab algn="l" pos="10215720"/>
              </a:tabLst>
            </a:pPr>
            <a:endParaRPr b="0" lang="en-US" sz="2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3977640" y="5096520"/>
            <a:ext cx="1675440" cy="2421360"/>
          </a:xfrm>
          <a:prstGeom prst="rect">
            <a:avLst/>
          </a:prstGeom>
          <a:noFill/>
          <a:ln w="0">
            <a:noFill/>
          </a:ln>
        </p:spPr>
        <p:txBody>
          <a:bodyPr lIns="78480" rIns="78480" tIns="39240" bIns="3924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785880"/>
                <a:tab algn="l" pos="1571760"/>
                <a:tab algn="l" pos="2357280"/>
                <a:tab algn="l" pos="3143160"/>
                <a:tab algn="l" pos="3929040"/>
                <a:tab algn="l" pos="4714920"/>
                <a:tab algn="l" pos="5500800"/>
                <a:tab algn="l" pos="6286680"/>
                <a:tab algn="l" pos="7072200"/>
                <a:tab algn="l" pos="7858080"/>
                <a:tab algn="l" pos="8643960"/>
                <a:tab algn="l" pos="9429840"/>
                <a:tab algn="l" pos="10215720"/>
              </a:tabLst>
            </a:pPr>
            <a:endParaRPr b="0" lang="en-US" sz="2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256DF2-5FBC-458C-A26E-B7638DB9695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8280" y="752400"/>
            <a:ext cx="5203800" cy="1409760"/>
          </a:xfrm>
          <a:prstGeom prst="rect">
            <a:avLst/>
          </a:prstGeom>
          <a:noFill/>
          <a:ln w="0">
            <a:noFill/>
          </a:ln>
        </p:spPr>
        <p:txBody>
          <a:bodyPr lIns="78480" rIns="78480" tIns="39240" bIns="39240" anchor="ctr">
            <a:noAutofit/>
          </a:bodyPr>
          <a:p>
            <a:pPr indent="0" algn="ctr">
              <a:buNone/>
              <a:tabLst>
                <a:tab algn="l" pos="0"/>
                <a:tab algn="l" pos="785880"/>
                <a:tab algn="l" pos="1571760"/>
                <a:tab algn="l" pos="2357280"/>
                <a:tab algn="l" pos="3143160"/>
                <a:tab algn="l" pos="3929040"/>
                <a:tab algn="l" pos="4714920"/>
                <a:tab algn="l" pos="5500800"/>
                <a:tab algn="l" pos="6286680"/>
                <a:tab algn="l" pos="7072200"/>
                <a:tab algn="l" pos="7858080"/>
                <a:tab algn="l" pos="8643960"/>
                <a:tab algn="l" pos="9429840"/>
                <a:tab algn="l" pos="10215720"/>
              </a:tabLst>
            </a:pPr>
            <a:endParaRPr b="0" lang="en-US" sz="3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8280" y="2444760"/>
            <a:ext cx="5203800" cy="5076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675"/>
              </a:spcBef>
              <a:buNone/>
              <a:tabLst>
                <a:tab algn="l" pos="0"/>
                <a:tab algn="l" pos="785880"/>
                <a:tab algn="l" pos="1571760"/>
                <a:tab algn="l" pos="2357280"/>
                <a:tab algn="l" pos="3143160"/>
                <a:tab algn="l" pos="3929040"/>
                <a:tab algn="l" pos="4714920"/>
                <a:tab algn="l" pos="5500800"/>
                <a:tab algn="l" pos="6286680"/>
                <a:tab algn="l" pos="7072200"/>
                <a:tab algn="l" pos="7858080"/>
                <a:tab algn="l" pos="8643960"/>
                <a:tab algn="l" pos="9429840"/>
                <a:tab algn="l" pos="10215720"/>
              </a:tabLst>
            </a:pPr>
            <a:endParaRPr b="0" lang="en-US" sz="2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E19898-964E-489A-AD48-5864A59DB95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8280" y="752400"/>
            <a:ext cx="5203800" cy="1409760"/>
          </a:xfrm>
          <a:prstGeom prst="rect">
            <a:avLst/>
          </a:prstGeom>
          <a:noFill/>
          <a:ln w="0">
            <a:noFill/>
          </a:ln>
        </p:spPr>
        <p:txBody>
          <a:bodyPr lIns="78480" rIns="78480" tIns="39240" bIns="39240" anchor="ctr">
            <a:noAutofit/>
          </a:bodyPr>
          <a:p>
            <a:pPr indent="0" algn="ctr">
              <a:buNone/>
              <a:tabLst>
                <a:tab algn="l" pos="0"/>
                <a:tab algn="l" pos="785880"/>
                <a:tab algn="l" pos="1571760"/>
                <a:tab algn="l" pos="2357280"/>
                <a:tab algn="l" pos="3143160"/>
                <a:tab algn="l" pos="3929040"/>
                <a:tab algn="l" pos="4714920"/>
                <a:tab algn="l" pos="5500800"/>
                <a:tab algn="l" pos="6286680"/>
                <a:tab algn="l" pos="7072200"/>
                <a:tab algn="l" pos="7858080"/>
                <a:tab algn="l" pos="8643960"/>
                <a:tab algn="l" pos="9429840"/>
                <a:tab algn="l" pos="10215720"/>
              </a:tabLst>
            </a:pPr>
            <a:endParaRPr b="0" lang="en-US" sz="3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8280" y="2444760"/>
            <a:ext cx="5203800" cy="5076720"/>
          </a:xfrm>
          <a:prstGeom prst="rect">
            <a:avLst/>
          </a:prstGeom>
          <a:noFill/>
          <a:ln w="0">
            <a:noFill/>
          </a:ln>
        </p:spPr>
        <p:txBody>
          <a:bodyPr lIns="78480" rIns="78480" tIns="39240" bIns="3924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785880"/>
                <a:tab algn="l" pos="1571760"/>
                <a:tab algn="l" pos="2357280"/>
                <a:tab algn="l" pos="3143160"/>
                <a:tab algn="l" pos="3929040"/>
                <a:tab algn="l" pos="4714920"/>
                <a:tab algn="l" pos="5500800"/>
                <a:tab algn="l" pos="6286680"/>
                <a:tab algn="l" pos="7072200"/>
                <a:tab algn="l" pos="7858080"/>
                <a:tab algn="l" pos="8643960"/>
                <a:tab algn="l" pos="9429840"/>
                <a:tab algn="l" pos="10215720"/>
              </a:tabLst>
            </a:pPr>
            <a:endParaRPr b="0" lang="en-US" sz="2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752564-A4B9-4FBA-9A02-72623E3CE30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8280" y="752400"/>
            <a:ext cx="5203800" cy="1409760"/>
          </a:xfrm>
          <a:prstGeom prst="rect">
            <a:avLst/>
          </a:prstGeom>
          <a:noFill/>
          <a:ln w="0">
            <a:noFill/>
          </a:ln>
        </p:spPr>
        <p:txBody>
          <a:bodyPr lIns="78480" rIns="78480" tIns="39240" bIns="39240" anchor="ctr">
            <a:noAutofit/>
          </a:bodyPr>
          <a:p>
            <a:pPr indent="0" algn="ctr">
              <a:buNone/>
              <a:tabLst>
                <a:tab algn="l" pos="0"/>
                <a:tab algn="l" pos="785880"/>
                <a:tab algn="l" pos="1571760"/>
                <a:tab algn="l" pos="2357280"/>
                <a:tab algn="l" pos="3143160"/>
                <a:tab algn="l" pos="3929040"/>
                <a:tab algn="l" pos="4714920"/>
                <a:tab algn="l" pos="5500800"/>
                <a:tab algn="l" pos="6286680"/>
                <a:tab algn="l" pos="7072200"/>
                <a:tab algn="l" pos="7858080"/>
                <a:tab algn="l" pos="8643960"/>
                <a:tab algn="l" pos="9429840"/>
                <a:tab algn="l" pos="10215720"/>
              </a:tabLst>
            </a:pPr>
            <a:endParaRPr b="0" lang="en-US" sz="3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8280" y="2444760"/>
            <a:ext cx="2539440" cy="5076720"/>
          </a:xfrm>
          <a:prstGeom prst="rect">
            <a:avLst/>
          </a:prstGeom>
          <a:noFill/>
          <a:ln w="0">
            <a:noFill/>
          </a:ln>
        </p:spPr>
        <p:txBody>
          <a:bodyPr lIns="78480" rIns="78480" tIns="39240" bIns="3924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785880"/>
                <a:tab algn="l" pos="1571760"/>
                <a:tab algn="l" pos="2357280"/>
                <a:tab algn="l" pos="3143160"/>
                <a:tab algn="l" pos="3929040"/>
                <a:tab algn="l" pos="4714920"/>
                <a:tab algn="l" pos="5500800"/>
                <a:tab algn="l" pos="6286680"/>
                <a:tab algn="l" pos="7072200"/>
                <a:tab algn="l" pos="7858080"/>
                <a:tab algn="l" pos="8643960"/>
                <a:tab algn="l" pos="9429840"/>
                <a:tab algn="l" pos="10215720"/>
              </a:tabLst>
            </a:pPr>
            <a:endParaRPr b="0" lang="en-US" sz="2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125160" y="2444760"/>
            <a:ext cx="2539440" cy="5076720"/>
          </a:xfrm>
          <a:prstGeom prst="rect">
            <a:avLst/>
          </a:prstGeom>
          <a:noFill/>
          <a:ln w="0">
            <a:noFill/>
          </a:ln>
        </p:spPr>
        <p:txBody>
          <a:bodyPr lIns="78480" rIns="78480" tIns="39240" bIns="3924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785880"/>
                <a:tab algn="l" pos="1571760"/>
                <a:tab algn="l" pos="2357280"/>
                <a:tab algn="l" pos="3143160"/>
                <a:tab algn="l" pos="3929040"/>
                <a:tab algn="l" pos="4714920"/>
                <a:tab algn="l" pos="5500800"/>
                <a:tab algn="l" pos="6286680"/>
                <a:tab algn="l" pos="7072200"/>
                <a:tab algn="l" pos="7858080"/>
                <a:tab algn="l" pos="8643960"/>
                <a:tab algn="l" pos="9429840"/>
                <a:tab algn="l" pos="10215720"/>
              </a:tabLst>
            </a:pPr>
            <a:endParaRPr b="0" lang="en-US" sz="2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0C2F0D-03FE-44B5-9758-4D989C0B72F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8280" y="752400"/>
            <a:ext cx="5203800" cy="1409760"/>
          </a:xfrm>
          <a:prstGeom prst="rect">
            <a:avLst/>
          </a:prstGeom>
          <a:noFill/>
          <a:ln w="0">
            <a:noFill/>
          </a:ln>
        </p:spPr>
        <p:txBody>
          <a:bodyPr lIns="78480" rIns="78480" tIns="39240" bIns="39240" anchor="ctr">
            <a:noAutofit/>
          </a:bodyPr>
          <a:p>
            <a:pPr indent="0" algn="ctr">
              <a:buNone/>
              <a:tabLst>
                <a:tab algn="l" pos="0"/>
                <a:tab algn="l" pos="785880"/>
                <a:tab algn="l" pos="1571760"/>
                <a:tab algn="l" pos="2357280"/>
                <a:tab algn="l" pos="3143160"/>
                <a:tab algn="l" pos="3929040"/>
                <a:tab algn="l" pos="4714920"/>
                <a:tab algn="l" pos="5500800"/>
                <a:tab algn="l" pos="6286680"/>
                <a:tab algn="l" pos="7072200"/>
                <a:tab algn="l" pos="7858080"/>
                <a:tab algn="l" pos="8643960"/>
                <a:tab algn="l" pos="9429840"/>
                <a:tab algn="l" pos="10215720"/>
              </a:tabLst>
            </a:pPr>
            <a:endParaRPr b="0" lang="en-US" sz="3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B80274-0240-4DDE-8426-A60E751125B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8280" y="752400"/>
            <a:ext cx="5203800" cy="6536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675"/>
              </a:spcBef>
              <a:tabLst>
                <a:tab algn="l" pos="0"/>
                <a:tab algn="l" pos="785880"/>
                <a:tab algn="l" pos="1571760"/>
                <a:tab algn="l" pos="2357280"/>
                <a:tab algn="l" pos="3143160"/>
                <a:tab algn="l" pos="3929040"/>
                <a:tab algn="l" pos="4714920"/>
                <a:tab algn="l" pos="5500800"/>
                <a:tab algn="l" pos="6286680"/>
                <a:tab algn="l" pos="7072200"/>
                <a:tab algn="l" pos="7858080"/>
                <a:tab algn="l" pos="8643960"/>
                <a:tab algn="l" pos="9429840"/>
                <a:tab algn="l" pos="10215720"/>
              </a:tabLst>
            </a:pPr>
            <a:endParaRPr b="0" lang="en-US" sz="2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969F92-1784-4186-BFD0-5EE5F9DC3BB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8280" y="752400"/>
            <a:ext cx="5203800" cy="1409760"/>
          </a:xfrm>
          <a:prstGeom prst="rect">
            <a:avLst/>
          </a:prstGeom>
          <a:noFill/>
          <a:ln w="0">
            <a:noFill/>
          </a:ln>
        </p:spPr>
        <p:txBody>
          <a:bodyPr lIns="78480" rIns="78480" tIns="39240" bIns="39240" anchor="ctr">
            <a:noAutofit/>
          </a:bodyPr>
          <a:p>
            <a:pPr indent="0" algn="ctr">
              <a:buNone/>
              <a:tabLst>
                <a:tab algn="l" pos="0"/>
                <a:tab algn="l" pos="785880"/>
                <a:tab algn="l" pos="1571760"/>
                <a:tab algn="l" pos="2357280"/>
                <a:tab algn="l" pos="3143160"/>
                <a:tab algn="l" pos="3929040"/>
                <a:tab algn="l" pos="4714920"/>
                <a:tab algn="l" pos="5500800"/>
                <a:tab algn="l" pos="6286680"/>
                <a:tab algn="l" pos="7072200"/>
                <a:tab algn="l" pos="7858080"/>
                <a:tab algn="l" pos="8643960"/>
                <a:tab algn="l" pos="9429840"/>
                <a:tab algn="l" pos="10215720"/>
              </a:tabLst>
            </a:pPr>
            <a:endParaRPr b="0" lang="en-US" sz="3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8280" y="2444760"/>
            <a:ext cx="2539440" cy="2421360"/>
          </a:xfrm>
          <a:prstGeom prst="rect">
            <a:avLst/>
          </a:prstGeom>
          <a:noFill/>
          <a:ln w="0">
            <a:noFill/>
          </a:ln>
        </p:spPr>
        <p:txBody>
          <a:bodyPr lIns="78480" rIns="78480" tIns="39240" bIns="3924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785880"/>
                <a:tab algn="l" pos="1571760"/>
                <a:tab algn="l" pos="2357280"/>
                <a:tab algn="l" pos="3143160"/>
                <a:tab algn="l" pos="3929040"/>
                <a:tab algn="l" pos="4714920"/>
                <a:tab algn="l" pos="5500800"/>
                <a:tab algn="l" pos="6286680"/>
                <a:tab algn="l" pos="7072200"/>
                <a:tab algn="l" pos="7858080"/>
                <a:tab algn="l" pos="8643960"/>
                <a:tab algn="l" pos="9429840"/>
                <a:tab algn="l" pos="10215720"/>
              </a:tabLst>
            </a:pPr>
            <a:endParaRPr b="0" lang="en-US" sz="2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125160" y="2444760"/>
            <a:ext cx="2539440" cy="5076720"/>
          </a:xfrm>
          <a:prstGeom prst="rect">
            <a:avLst/>
          </a:prstGeom>
          <a:noFill/>
          <a:ln w="0">
            <a:noFill/>
          </a:ln>
        </p:spPr>
        <p:txBody>
          <a:bodyPr lIns="78480" rIns="78480" tIns="39240" bIns="3924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785880"/>
                <a:tab algn="l" pos="1571760"/>
                <a:tab algn="l" pos="2357280"/>
                <a:tab algn="l" pos="3143160"/>
                <a:tab algn="l" pos="3929040"/>
                <a:tab algn="l" pos="4714920"/>
                <a:tab algn="l" pos="5500800"/>
                <a:tab algn="l" pos="6286680"/>
                <a:tab algn="l" pos="7072200"/>
                <a:tab algn="l" pos="7858080"/>
                <a:tab algn="l" pos="8643960"/>
                <a:tab algn="l" pos="9429840"/>
                <a:tab algn="l" pos="10215720"/>
              </a:tabLst>
            </a:pPr>
            <a:endParaRPr b="0" lang="en-US" sz="2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8280" y="5096520"/>
            <a:ext cx="2539440" cy="2421360"/>
          </a:xfrm>
          <a:prstGeom prst="rect">
            <a:avLst/>
          </a:prstGeom>
          <a:noFill/>
          <a:ln w="0">
            <a:noFill/>
          </a:ln>
        </p:spPr>
        <p:txBody>
          <a:bodyPr lIns="78480" rIns="78480" tIns="39240" bIns="3924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785880"/>
                <a:tab algn="l" pos="1571760"/>
                <a:tab algn="l" pos="2357280"/>
                <a:tab algn="l" pos="3143160"/>
                <a:tab algn="l" pos="3929040"/>
                <a:tab algn="l" pos="4714920"/>
                <a:tab algn="l" pos="5500800"/>
                <a:tab algn="l" pos="6286680"/>
                <a:tab algn="l" pos="7072200"/>
                <a:tab algn="l" pos="7858080"/>
                <a:tab algn="l" pos="8643960"/>
                <a:tab algn="l" pos="9429840"/>
                <a:tab algn="l" pos="10215720"/>
              </a:tabLst>
            </a:pPr>
            <a:endParaRPr b="0" lang="en-US" sz="2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D0BE73-5EA1-474B-9E22-759C4A0B36E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8280" y="752400"/>
            <a:ext cx="5203800" cy="1409760"/>
          </a:xfrm>
          <a:prstGeom prst="rect">
            <a:avLst/>
          </a:prstGeom>
          <a:noFill/>
          <a:ln w="0">
            <a:noFill/>
          </a:ln>
        </p:spPr>
        <p:txBody>
          <a:bodyPr lIns="78480" rIns="78480" tIns="39240" bIns="39240" anchor="ctr">
            <a:noAutofit/>
          </a:bodyPr>
          <a:p>
            <a:pPr indent="0" algn="ctr">
              <a:buNone/>
              <a:tabLst>
                <a:tab algn="l" pos="0"/>
                <a:tab algn="l" pos="785880"/>
                <a:tab algn="l" pos="1571760"/>
                <a:tab algn="l" pos="2357280"/>
                <a:tab algn="l" pos="3143160"/>
                <a:tab algn="l" pos="3929040"/>
                <a:tab algn="l" pos="4714920"/>
                <a:tab algn="l" pos="5500800"/>
                <a:tab algn="l" pos="6286680"/>
                <a:tab algn="l" pos="7072200"/>
                <a:tab algn="l" pos="7858080"/>
                <a:tab algn="l" pos="8643960"/>
                <a:tab algn="l" pos="9429840"/>
                <a:tab algn="l" pos="10215720"/>
              </a:tabLst>
            </a:pPr>
            <a:endParaRPr b="0" lang="en-US" sz="3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8280" y="2444760"/>
            <a:ext cx="2539440" cy="5076720"/>
          </a:xfrm>
          <a:prstGeom prst="rect">
            <a:avLst/>
          </a:prstGeom>
          <a:noFill/>
          <a:ln w="0">
            <a:noFill/>
          </a:ln>
        </p:spPr>
        <p:txBody>
          <a:bodyPr lIns="78480" rIns="78480" tIns="39240" bIns="3924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785880"/>
                <a:tab algn="l" pos="1571760"/>
                <a:tab algn="l" pos="2357280"/>
                <a:tab algn="l" pos="3143160"/>
                <a:tab algn="l" pos="3929040"/>
                <a:tab algn="l" pos="4714920"/>
                <a:tab algn="l" pos="5500800"/>
                <a:tab algn="l" pos="6286680"/>
                <a:tab algn="l" pos="7072200"/>
                <a:tab algn="l" pos="7858080"/>
                <a:tab algn="l" pos="8643960"/>
                <a:tab algn="l" pos="9429840"/>
                <a:tab algn="l" pos="10215720"/>
              </a:tabLst>
            </a:pPr>
            <a:endParaRPr b="0" lang="en-US" sz="2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125160" y="2444760"/>
            <a:ext cx="2539440" cy="2421360"/>
          </a:xfrm>
          <a:prstGeom prst="rect">
            <a:avLst/>
          </a:prstGeom>
          <a:noFill/>
          <a:ln w="0">
            <a:noFill/>
          </a:ln>
        </p:spPr>
        <p:txBody>
          <a:bodyPr lIns="78480" rIns="78480" tIns="39240" bIns="3924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785880"/>
                <a:tab algn="l" pos="1571760"/>
                <a:tab algn="l" pos="2357280"/>
                <a:tab algn="l" pos="3143160"/>
                <a:tab algn="l" pos="3929040"/>
                <a:tab algn="l" pos="4714920"/>
                <a:tab algn="l" pos="5500800"/>
                <a:tab algn="l" pos="6286680"/>
                <a:tab algn="l" pos="7072200"/>
                <a:tab algn="l" pos="7858080"/>
                <a:tab algn="l" pos="8643960"/>
                <a:tab algn="l" pos="9429840"/>
                <a:tab algn="l" pos="10215720"/>
              </a:tabLst>
            </a:pPr>
            <a:endParaRPr b="0" lang="en-US" sz="2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125160" y="5096520"/>
            <a:ext cx="2539440" cy="2421360"/>
          </a:xfrm>
          <a:prstGeom prst="rect">
            <a:avLst/>
          </a:prstGeom>
          <a:noFill/>
          <a:ln w="0">
            <a:noFill/>
          </a:ln>
        </p:spPr>
        <p:txBody>
          <a:bodyPr lIns="78480" rIns="78480" tIns="39240" bIns="3924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785880"/>
                <a:tab algn="l" pos="1571760"/>
                <a:tab algn="l" pos="2357280"/>
                <a:tab algn="l" pos="3143160"/>
                <a:tab algn="l" pos="3929040"/>
                <a:tab algn="l" pos="4714920"/>
                <a:tab algn="l" pos="5500800"/>
                <a:tab algn="l" pos="6286680"/>
                <a:tab algn="l" pos="7072200"/>
                <a:tab algn="l" pos="7858080"/>
                <a:tab algn="l" pos="8643960"/>
                <a:tab algn="l" pos="9429840"/>
                <a:tab algn="l" pos="10215720"/>
              </a:tabLst>
            </a:pPr>
            <a:endParaRPr b="0" lang="en-US" sz="2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B21C46-6D7D-41E3-BCA5-6B4CBB4EFB3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8280" y="752400"/>
            <a:ext cx="5203800" cy="1409760"/>
          </a:xfrm>
          <a:prstGeom prst="rect">
            <a:avLst/>
          </a:prstGeom>
          <a:noFill/>
          <a:ln w="0">
            <a:noFill/>
          </a:ln>
        </p:spPr>
        <p:txBody>
          <a:bodyPr lIns="78480" rIns="78480" tIns="39240" bIns="39240" anchor="ctr">
            <a:noAutofit/>
          </a:bodyPr>
          <a:p>
            <a:pPr indent="0" algn="ctr">
              <a:buNone/>
              <a:tabLst>
                <a:tab algn="l" pos="0"/>
                <a:tab algn="l" pos="785880"/>
                <a:tab algn="l" pos="1571760"/>
                <a:tab algn="l" pos="2357280"/>
                <a:tab algn="l" pos="3143160"/>
                <a:tab algn="l" pos="3929040"/>
                <a:tab algn="l" pos="4714920"/>
                <a:tab algn="l" pos="5500800"/>
                <a:tab algn="l" pos="6286680"/>
                <a:tab algn="l" pos="7072200"/>
                <a:tab algn="l" pos="7858080"/>
                <a:tab algn="l" pos="8643960"/>
                <a:tab algn="l" pos="9429840"/>
                <a:tab algn="l" pos="10215720"/>
              </a:tabLst>
            </a:pPr>
            <a:endParaRPr b="0" lang="en-US" sz="3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8280" y="2444760"/>
            <a:ext cx="2539440" cy="2421360"/>
          </a:xfrm>
          <a:prstGeom prst="rect">
            <a:avLst/>
          </a:prstGeom>
          <a:noFill/>
          <a:ln w="0">
            <a:noFill/>
          </a:ln>
        </p:spPr>
        <p:txBody>
          <a:bodyPr lIns="78480" rIns="78480" tIns="39240" bIns="3924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785880"/>
                <a:tab algn="l" pos="1571760"/>
                <a:tab algn="l" pos="2357280"/>
                <a:tab algn="l" pos="3143160"/>
                <a:tab algn="l" pos="3929040"/>
                <a:tab algn="l" pos="4714920"/>
                <a:tab algn="l" pos="5500800"/>
                <a:tab algn="l" pos="6286680"/>
                <a:tab algn="l" pos="7072200"/>
                <a:tab algn="l" pos="7858080"/>
                <a:tab algn="l" pos="8643960"/>
                <a:tab algn="l" pos="9429840"/>
                <a:tab algn="l" pos="10215720"/>
              </a:tabLst>
            </a:pPr>
            <a:endParaRPr b="0" lang="en-US" sz="2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125160" y="2444760"/>
            <a:ext cx="2539440" cy="2421360"/>
          </a:xfrm>
          <a:prstGeom prst="rect">
            <a:avLst/>
          </a:prstGeom>
          <a:noFill/>
          <a:ln w="0">
            <a:noFill/>
          </a:ln>
        </p:spPr>
        <p:txBody>
          <a:bodyPr lIns="78480" rIns="78480" tIns="39240" bIns="3924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785880"/>
                <a:tab algn="l" pos="1571760"/>
                <a:tab algn="l" pos="2357280"/>
                <a:tab algn="l" pos="3143160"/>
                <a:tab algn="l" pos="3929040"/>
                <a:tab algn="l" pos="4714920"/>
                <a:tab algn="l" pos="5500800"/>
                <a:tab algn="l" pos="6286680"/>
                <a:tab algn="l" pos="7072200"/>
                <a:tab algn="l" pos="7858080"/>
                <a:tab algn="l" pos="8643960"/>
                <a:tab algn="l" pos="9429840"/>
                <a:tab algn="l" pos="10215720"/>
              </a:tabLst>
            </a:pPr>
            <a:endParaRPr b="0" lang="en-US" sz="2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8280" y="5096520"/>
            <a:ext cx="5203800" cy="2421360"/>
          </a:xfrm>
          <a:prstGeom prst="rect">
            <a:avLst/>
          </a:prstGeom>
          <a:noFill/>
          <a:ln w="0">
            <a:noFill/>
          </a:ln>
        </p:spPr>
        <p:txBody>
          <a:bodyPr lIns="78480" rIns="78480" tIns="39240" bIns="3924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785880"/>
                <a:tab algn="l" pos="1571760"/>
                <a:tab algn="l" pos="2357280"/>
                <a:tab algn="l" pos="3143160"/>
                <a:tab algn="l" pos="3929040"/>
                <a:tab algn="l" pos="4714920"/>
                <a:tab algn="l" pos="5500800"/>
                <a:tab algn="l" pos="6286680"/>
                <a:tab algn="l" pos="7072200"/>
                <a:tab algn="l" pos="7858080"/>
                <a:tab algn="l" pos="8643960"/>
                <a:tab algn="l" pos="9429840"/>
                <a:tab algn="l" pos="10215720"/>
              </a:tabLst>
            </a:pPr>
            <a:endParaRPr b="0" lang="en-US" sz="2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83F093-D136-443E-9241-8840CFF634F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8280" y="752400"/>
            <a:ext cx="5203800" cy="1409760"/>
          </a:xfrm>
          <a:prstGeom prst="rect">
            <a:avLst/>
          </a:prstGeom>
          <a:noFill/>
          <a:ln w="0">
            <a:noFill/>
          </a:ln>
        </p:spPr>
        <p:txBody>
          <a:bodyPr lIns="78480" rIns="78480" tIns="39240" bIns="39240" anchor="ctr">
            <a:noAutofit/>
          </a:bodyPr>
          <a:p>
            <a:pPr indent="0" algn="ctr">
              <a:buNone/>
              <a:tabLst>
                <a:tab algn="l" pos="0"/>
                <a:tab algn="l" pos="785880"/>
                <a:tab algn="l" pos="1571760"/>
                <a:tab algn="l" pos="2357280"/>
                <a:tab algn="l" pos="3143160"/>
                <a:tab algn="l" pos="3929040"/>
                <a:tab algn="l" pos="4714920"/>
                <a:tab algn="l" pos="5500800"/>
                <a:tab algn="l" pos="6286680"/>
                <a:tab algn="l" pos="7072200"/>
                <a:tab algn="l" pos="7858080"/>
                <a:tab algn="l" pos="8643960"/>
                <a:tab algn="l" pos="9429840"/>
                <a:tab algn="l" pos="10215720"/>
              </a:tabLst>
            </a:pPr>
            <a:r>
              <a:rPr b="0" lang="en-US" sz="38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3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8280" y="2444760"/>
            <a:ext cx="5203800" cy="5076720"/>
          </a:xfrm>
          <a:prstGeom prst="rect">
            <a:avLst/>
          </a:prstGeom>
          <a:noFill/>
          <a:ln w="0">
            <a:noFill/>
          </a:ln>
        </p:spPr>
        <p:txBody>
          <a:bodyPr lIns="78480" rIns="78480" tIns="39240" bIns="39240" anchor="t">
            <a:normAutofit/>
          </a:bodyPr>
          <a:p>
            <a:pPr marL="295200" indent="-295200">
              <a:spcBef>
                <a:spcPts val="675"/>
              </a:spcBef>
              <a:buClr>
                <a:srgbClr val="000000"/>
              </a:buClr>
              <a:buFont typeface="Times"/>
              <a:buChar char="•"/>
              <a:tabLst>
                <a:tab algn="l" pos="785880"/>
                <a:tab algn="l" pos="1571760"/>
                <a:tab algn="l" pos="2357280"/>
                <a:tab algn="l" pos="3143160"/>
                <a:tab algn="l" pos="3929040"/>
                <a:tab algn="l" pos="4714920"/>
                <a:tab algn="l" pos="5500800"/>
                <a:tab algn="l" pos="6286680"/>
                <a:tab algn="l" pos="7072200"/>
                <a:tab algn="l" pos="7858080"/>
                <a:tab algn="l" pos="8643960"/>
                <a:tab algn="l" pos="9429840"/>
                <a:tab algn="l" pos="10215720"/>
              </a:tabLst>
            </a:pPr>
            <a:r>
              <a:rPr b="0" lang="en-US" sz="27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2700" spc="-1" strike="noStrike">
              <a:solidFill>
                <a:srgbClr val="000000"/>
              </a:solidFill>
              <a:latin typeface="Times New Roman"/>
            </a:endParaRPr>
          </a:p>
          <a:p>
            <a:pPr lvl="1" marL="638280" indent="-246240">
              <a:spcBef>
                <a:spcPts val="675"/>
              </a:spcBef>
              <a:buClr>
                <a:srgbClr val="000000"/>
              </a:buClr>
              <a:buFont typeface="Times"/>
              <a:buChar char="–"/>
              <a:tabLst>
                <a:tab algn="l" pos="785880"/>
                <a:tab algn="l" pos="1571760"/>
                <a:tab algn="l" pos="2357280"/>
                <a:tab algn="l" pos="3143160"/>
                <a:tab algn="l" pos="3929040"/>
                <a:tab algn="l" pos="4714920"/>
                <a:tab algn="l" pos="5500800"/>
                <a:tab algn="l" pos="6286680"/>
                <a:tab algn="l" pos="7072200"/>
                <a:tab algn="l" pos="7858080"/>
                <a:tab algn="l" pos="8643960"/>
                <a:tab algn="l" pos="9429840"/>
                <a:tab algn="l" pos="10215720"/>
              </a:tabLst>
            </a:pPr>
            <a:r>
              <a:rPr b="0" lang="en-US" sz="27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2700" spc="-1" strike="noStrike">
              <a:solidFill>
                <a:srgbClr val="000000"/>
              </a:solidFill>
              <a:latin typeface="Times New Roman"/>
            </a:endParaRPr>
          </a:p>
          <a:p>
            <a:pPr lvl="2" marL="981000" indent="-195120">
              <a:spcBef>
                <a:spcPts val="675"/>
              </a:spcBef>
              <a:buClr>
                <a:srgbClr val="000000"/>
              </a:buClr>
              <a:buFont typeface="Times"/>
              <a:buChar char="•"/>
              <a:tabLst>
                <a:tab algn="l" pos="785880"/>
                <a:tab algn="l" pos="1571760"/>
                <a:tab algn="l" pos="2357280"/>
                <a:tab algn="l" pos="3143160"/>
                <a:tab algn="l" pos="3929040"/>
                <a:tab algn="l" pos="4714920"/>
                <a:tab algn="l" pos="5500800"/>
                <a:tab algn="l" pos="6286680"/>
                <a:tab algn="l" pos="7072200"/>
                <a:tab algn="l" pos="7858080"/>
                <a:tab algn="l" pos="8643960"/>
                <a:tab algn="l" pos="9429840"/>
                <a:tab algn="l" pos="10215720"/>
              </a:tabLst>
            </a:pPr>
            <a:r>
              <a:rPr b="0" lang="en-US" sz="27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2700" spc="-1" strike="noStrike">
              <a:solidFill>
                <a:srgbClr val="000000"/>
              </a:solidFill>
              <a:latin typeface="Times New Roman"/>
            </a:endParaRPr>
          </a:p>
          <a:p>
            <a:pPr lvl="3" marL="1374840" indent="-196920">
              <a:spcBef>
                <a:spcPts val="675"/>
              </a:spcBef>
              <a:buClr>
                <a:srgbClr val="000000"/>
              </a:buClr>
              <a:buFont typeface="Times"/>
              <a:buChar char="–"/>
              <a:tabLst>
                <a:tab algn="l" pos="785880"/>
                <a:tab algn="l" pos="1571760"/>
                <a:tab algn="l" pos="2357280"/>
                <a:tab algn="l" pos="3143160"/>
                <a:tab algn="l" pos="3929040"/>
                <a:tab algn="l" pos="4714920"/>
                <a:tab algn="l" pos="5500800"/>
                <a:tab algn="l" pos="6286680"/>
                <a:tab algn="l" pos="7072200"/>
                <a:tab algn="l" pos="7858080"/>
                <a:tab algn="l" pos="8643960"/>
                <a:tab algn="l" pos="9429840"/>
                <a:tab algn="l" pos="10215720"/>
              </a:tabLst>
            </a:pPr>
            <a:r>
              <a:rPr b="0" lang="en-US" sz="27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2700" spc="-1" strike="noStrike">
              <a:solidFill>
                <a:srgbClr val="000000"/>
              </a:solidFill>
              <a:latin typeface="Times New Roman"/>
            </a:endParaRPr>
          </a:p>
          <a:p>
            <a:pPr lvl="4" marL="1766880" indent="-195120">
              <a:spcBef>
                <a:spcPts val="675"/>
              </a:spcBef>
              <a:buClr>
                <a:srgbClr val="000000"/>
              </a:buClr>
              <a:buFont typeface="Times"/>
              <a:buChar char="»"/>
              <a:tabLst>
                <a:tab algn="l" pos="785880"/>
                <a:tab algn="l" pos="1571760"/>
                <a:tab algn="l" pos="2357280"/>
                <a:tab algn="l" pos="3143160"/>
                <a:tab algn="l" pos="3929040"/>
                <a:tab algn="l" pos="4714920"/>
                <a:tab algn="l" pos="5500800"/>
                <a:tab algn="l" pos="6286680"/>
                <a:tab algn="l" pos="7072200"/>
                <a:tab algn="l" pos="7858080"/>
                <a:tab algn="l" pos="8643960"/>
                <a:tab algn="l" pos="9429840"/>
                <a:tab algn="l" pos="10215720"/>
              </a:tabLst>
            </a:pPr>
            <a:r>
              <a:rPr b="0" lang="en-US" sz="27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2700" spc="-1" strike="noStrike">
              <a:solidFill>
                <a:srgbClr val="000000"/>
              </a:solidFill>
              <a:latin typeface="Times New Roman"/>
            </a:endParaRPr>
          </a:p>
          <a:p>
            <a:pPr lvl="5" marL="1766880" indent="-195120">
              <a:spcBef>
                <a:spcPts val="675"/>
              </a:spcBef>
              <a:buClr>
                <a:srgbClr val="000000"/>
              </a:buClr>
              <a:buFont typeface="Times"/>
              <a:buChar char="»"/>
              <a:tabLst>
                <a:tab algn="l" pos="785880"/>
                <a:tab algn="l" pos="1571760"/>
                <a:tab algn="l" pos="2357280"/>
                <a:tab algn="l" pos="3143160"/>
                <a:tab algn="l" pos="3929040"/>
                <a:tab algn="l" pos="4714920"/>
                <a:tab algn="l" pos="5500800"/>
                <a:tab algn="l" pos="6286680"/>
                <a:tab algn="l" pos="7072200"/>
                <a:tab algn="l" pos="7858080"/>
                <a:tab algn="l" pos="8643960"/>
                <a:tab algn="l" pos="9429840"/>
                <a:tab algn="l" pos="10215720"/>
              </a:tabLst>
            </a:pPr>
            <a:r>
              <a:rPr b="0" lang="en-US" sz="27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2700" spc="-1" strike="noStrike">
              <a:solidFill>
                <a:srgbClr val="000000"/>
              </a:solidFill>
              <a:latin typeface="Times New Roman"/>
            </a:endParaRPr>
          </a:p>
          <a:p>
            <a:pPr lvl="6" marL="1766880" indent="-195120">
              <a:spcBef>
                <a:spcPts val="675"/>
              </a:spcBef>
              <a:buClr>
                <a:srgbClr val="000000"/>
              </a:buClr>
              <a:buFont typeface="Times"/>
              <a:buChar char="»"/>
              <a:tabLst>
                <a:tab algn="l" pos="785880"/>
                <a:tab algn="l" pos="1571760"/>
                <a:tab algn="l" pos="2357280"/>
                <a:tab algn="l" pos="3143160"/>
                <a:tab algn="l" pos="3929040"/>
                <a:tab algn="l" pos="4714920"/>
                <a:tab algn="l" pos="5500800"/>
                <a:tab algn="l" pos="6286680"/>
                <a:tab algn="l" pos="7072200"/>
                <a:tab algn="l" pos="7858080"/>
                <a:tab algn="l" pos="8643960"/>
                <a:tab algn="l" pos="9429840"/>
                <a:tab algn="l" pos="10215720"/>
              </a:tabLst>
            </a:pPr>
            <a:r>
              <a:rPr b="0" lang="en-US" sz="27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2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8640" y="7708680"/>
            <a:ext cx="1276560" cy="563400"/>
          </a:xfrm>
          <a:prstGeom prst="rect">
            <a:avLst/>
          </a:prstGeom>
          <a:noFill/>
          <a:ln w="0">
            <a:noFill/>
          </a:ln>
        </p:spPr>
        <p:txBody>
          <a:bodyPr lIns="78480" rIns="78480" tIns="39240" bIns="39240" anchor="t">
            <a:noAutofit/>
          </a:bodyPr>
          <a:lstStyle>
            <a:lvl1pPr indent="0">
              <a:buNone/>
              <a:tabLst>
                <a:tab algn="l" pos="0"/>
                <a:tab algn="l" pos="785880"/>
                <a:tab algn="l" pos="1571760"/>
                <a:tab algn="l" pos="2357280"/>
                <a:tab algn="l" pos="3143160"/>
                <a:tab algn="l" pos="3929040"/>
                <a:tab algn="l" pos="4714920"/>
                <a:tab algn="l" pos="5500800"/>
                <a:tab algn="l" pos="6286680"/>
                <a:tab algn="l" pos="7072200"/>
                <a:tab algn="l" pos="7858080"/>
                <a:tab algn="l" pos="8643960"/>
                <a:tab algn="l" pos="9429840"/>
                <a:tab algn="l" pos="10215720"/>
              </a:tabLst>
              <a:defRPr b="0" lang="en-US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785880"/>
                <a:tab algn="l" pos="1571760"/>
                <a:tab algn="l" pos="2357280"/>
                <a:tab algn="l" pos="3143160"/>
                <a:tab algn="l" pos="3929040"/>
                <a:tab algn="l" pos="4714920"/>
                <a:tab algn="l" pos="5500800"/>
                <a:tab algn="l" pos="6286680"/>
                <a:tab algn="l" pos="7072200"/>
                <a:tab algn="l" pos="7858080"/>
                <a:tab algn="l" pos="8643960"/>
                <a:tab algn="l" pos="9429840"/>
                <a:tab algn="l" pos="102157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090880" y="7708680"/>
            <a:ext cx="1939680" cy="563400"/>
          </a:xfrm>
          <a:prstGeom prst="rect">
            <a:avLst/>
          </a:prstGeom>
          <a:noFill/>
          <a:ln w="0">
            <a:noFill/>
          </a:ln>
        </p:spPr>
        <p:txBody>
          <a:bodyPr lIns="78480" rIns="78480" tIns="39240" bIns="39240" anchor="t">
            <a:noAutofit/>
          </a:bodyPr>
          <a:lstStyle>
            <a:lvl1pPr indent="0" algn="ctr">
              <a:buNone/>
              <a:tabLst>
                <a:tab algn="l" pos="0"/>
                <a:tab algn="l" pos="785880"/>
                <a:tab algn="l" pos="1571760"/>
                <a:tab algn="l" pos="2357280"/>
                <a:tab algn="l" pos="3143160"/>
                <a:tab algn="l" pos="3929040"/>
                <a:tab algn="l" pos="4714920"/>
                <a:tab algn="l" pos="5500800"/>
                <a:tab algn="l" pos="6286680"/>
                <a:tab algn="l" pos="7072200"/>
                <a:tab algn="l" pos="7858080"/>
                <a:tab algn="l" pos="8643960"/>
                <a:tab algn="l" pos="9429840"/>
                <a:tab algn="l" pos="10215720"/>
              </a:tabLst>
              <a:defRPr b="0" lang="en-US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785880"/>
                <a:tab algn="l" pos="1571760"/>
                <a:tab algn="l" pos="2357280"/>
                <a:tab algn="l" pos="3143160"/>
                <a:tab algn="l" pos="3929040"/>
                <a:tab algn="l" pos="4714920"/>
                <a:tab algn="l" pos="5500800"/>
                <a:tab algn="l" pos="6286680"/>
                <a:tab algn="l" pos="7072200"/>
                <a:tab algn="l" pos="7858080"/>
                <a:tab algn="l" pos="8643960"/>
                <a:tab algn="l" pos="9429840"/>
                <a:tab algn="l" pos="102157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385880" y="7708680"/>
            <a:ext cx="1276200" cy="563400"/>
          </a:xfrm>
          <a:prstGeom prst="rect">
            <a:avLst/>
          </a:prstGeom>
          <a:noFill/>
          <a:ln w="0">
            <a:noFill/>
          </a:ln>
        </p:spPr>
        <p:txBody>
          <a:bodyPr lIns="78480" rIns="78480" tIns="39240" bIns="39240" anchor="t">
            <a:noAutofit/>
          </a:bodyPr>
          <a:lstStyle>
            <a:lvl1pPr indent="0" algn="r">
              <a:buNone/>
              <a:tabLst>
                <a:tab algn="l" pos="0"/>
                <a:tab algn="l" pos="785880"/>
                <a:tab algn="l" pos="1571760"/>
                <a:tab algn="l" pos="2357280"/>
                <a:tab algn="l" pos="3143160"/>
                <a:tab algn="l" pos="3929040"/>
                <a:tab algn="l" pos="4714920"/>
                <a:tab algn="l" pos="5500800"/>
                <a:tab algn="l" pos="6286680"/>
                <a:tab algn="l" pos="7072200"/>
                <a:tab algn="l" pos="7858080"/>
                <a:tab algn="l" pos="8643960"/>
                <a:tab algn="l" pos="9429840"/>
                <a:tab algn="l" pos="10215720"/>
              </a:tabLst>
              <a:defRPr b="0" lang="en-US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785880"/>
                <a:tab algn="l" pos="1571760"/>
                <a:tab algn="l" pos="2357280"/>
                <a:tab algn="l" pos="3143160"/>
                <a:tab algn="l" pos="3929040"/>
                <a:tab algn="l" pos="4714920"/>
                <a:tab algn="l" pos="5500800"/>
                <a:tab algn="l" pos="6286680"/>
                <a:tab algn="l" pos="7072200"/>
                <a:tab algn="l" pos="7858080"/>
                <a:tab algn="l" pos="8643960"/>
                <a:tab algn="l" pos="9429840"/>
                <a:tab algn="l" pos="10215720"/>
              </a:tabLst>
            </a:pPr>
            <a:fld id="{40BDAAEC-6367-41C3-A4B7-DAF4897DCFE8}" type="slidenum"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07360" y="237960"/>
            <a:ext cx="5710680" cy="7978680"/>
            <a:chOff x="207360" y="237960"/>
            <a:chExt cx="5710680" cy="7978680"/>
          </a:xfrm>
        </p:grpSpPr>
        <p:grpSp>
          <p:nvGrpSpPr>
            <p:cNvPr id="42" name=""/>
            <p:cNvGrpSpPr/>
            <p:nvPr/>
          </p:nvGrpSpPr>
          <p:grpSpPr>
            <a:xfrm>
              <a:off x="207360" y="5475240"/>
              <a:ext cx="5710680" cy="2741400"/>
              <a:chOff x="207360" y="5475240"/>
              <a:chExt cx="5710680" cy="2741400"/>
            </a:xfrm>
          </p:grpSpPr>
          <p:sp>
            <p:nvSpPr>
              <p:cNvPr id="43" name=""/>
              <p:cNvSpPr/>
              <p:nvPr/>
            </p:nvSpPr>
            <p:spPr>
              <a:xfrm>
                <a:off x="3038400" y="6913440"/>
                <a:ext cx="2879640" cy="14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4" name=""/>
              <p:cNvSpPr/>
              <p:nvPr/>
            </p:nvSpPr>
            <p:spPr>
              <a:xfrm>
                <a:off x="517320" y="8215200"/>
                <a:ext cx="5399280" cy="14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5" name=""/>
              <p:cNvSpPr/>
              <p:nvPr/>
            </p:nvSpPr>
            <p:spPr>
              <a:xfrm>
                <a:off x="519120" y="6362640"/>
                <a:ext cx="5398920" cy="14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6" name=""/>
              <p:cNvSpPr/>
              <p:nvPr/>
            </p:nvSpPr>
            <p:spPr>
              <a:xfrm>
                <a:off x="1912320" y="5870520"/>
                <a:ext cx="2896560" cy="429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2200" spc="-1" strike="noStrike">
                    <a:solidFill>
                      <a:srgbClr val="000000"/>
                    </a:solidFill>
                    <a:latin typeface="Arial"/>
                  </a:rPr>
                  <a:t>mRNA molecules/pg</a:t>
                </a:r>
                <a:endParaRPr b="0" lang="en-US" sz="2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3529440" y="7094520"/>
                <a:ext cx="6242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800" spc="-1" strike="noStrike">
                    <a:solidFill>
                      <a:srgbClr val="000000"/>
                    </a:solidFill>
                    <a:latin typeface="Arial"/>
                  </a:rPr>
                  <a:t>17.6</a:t>
                </a:r>
                <a:endParaRPr b="0" lang="en-US" sz="1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>
                <a:off x="4651920" y="7094520"/>
                <a:ext cx="6242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800" spc="-1" strike="noStrike">
                    <a:solidFill>
                      <a:srgbClr val="000000"/>
                    </a:solidFill>
                    <a:latin typeface="Arial"/>
                  </a:rPr>
                  <a:t>12.9</a:t>
                </a:r>
                <a:endParaRPr b="0" lang="en-US" sz="1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553680" y="7094520"/>
                <a:ext cx="21466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800" spc="-1" strike="noStrike">
                    <a:solidFill>
                      <a:srgbClr val="000000"/>
                    </a:solidFill>
                    <a:latin typeface="Arial"/>
                  </a:rPr>
                  <a:t>random hexamers</a:t>
                </a:r>
                <a:endParaRPr b="0" lang="en-US" sz="1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3478320" y="6451560"/>
                <a:ext cx="7264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s-ES" sz="1800" spc="-1" strike="noStrike">
                    <a:solidFill>
                      <a:srgbClr val="000000"/>
                    </a:solidFill>
                    <a:latin typeface="Arial"/>
                  </a:rPr>
                  <a:t>c-fos</a:t>
                </a:r>
                <a:endParaRPr b="0" lang="en-US" sz="1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4499280" y="6451560"/>
                <a:ext cx="9291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s-ES" sz="1800" spc="-1" strike="noStrike">
                    <a:solidFill>
                      <a:srgbClr val="000000"/>
                    </a:solidFill>
                    <a:latin typeface="Arial"/>
                  </a:rPr>
                  <a:t>c-fos-2</a:t>
                </a:r>
                <a:endParaRPr b="0" lang="en-US" sz="1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3529440" y="7700760"/>
                <a:ext cx="6242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800" spc="-1" strike="noStrike">
                    <a:solidFill>
                      <a:srgbClr val="000000"/>
                    </a:solidFill>
                    <a:latin typeface="Arial"/>
                  </a:rPr>
                  <a:t>16.1</a:t>
                </a:r>
                <a:endParaRPr b="0" lang="en-US" sz="1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4651920" y="7700760"/>
                <a:ext cx="6242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800" spc="-1" strike="noStrike">
                    <a:solidFill>
                      <a:srgbClr val="000000"/>
                    </a:solidFill>
                    <a:latin typeface="Arial"/>
                  </a:rPr>
                  <a:t>13.9</a:t>
                </a:r>
                <a:endParaRPr b="0" lang="en-US" sz="1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>
                <a:off x="550800" y="7700760"/>
                <a:ext cx="2511360" cy="405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800" spc="-1" strike="noStrike">
                    <a:solidFill>
                      <a:srgbClr val="000000"/>
                    </a:solidFill>
                    <a:latin typeface="Arial"/>
                  </a:rPr>
                  <a:t>oligo (dT)</a:t>
                </a:r>
                <a:r>
                  <a:rPr b="1" lang="es-ES" sz="1800" spc="-1" strike="noStrike" baseline="-25000">
                    <a:solidFill>
                      <a:srgbClr val="000000"/>
                    </a:solidFill>
                    <a:latin typeface="Arial"/>
                  </a:rPr>
                  <a:t>20</a:t>
                </a:r>
                <a:r>
                  <a:rPr b="1" lang="es-ES" sz="1800" spc="-1" strike="noStrike">
                    <a:solidFill>
                      <a:srgbClr val="000000"/>
                    </a:solidFill>
                    <a:latin typeface="Arial"/>
                  </a:rPr>
                  <a:t> primer</a:t>
                </a:r>
                <a:endParaRPr b="0" lang="en-US" sz="1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207360" y="5475240"/>
                <a:ext cx="610560" cy="581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3200" spc="-1" strike="noStrike">
                    <a:solidFill>
                      <a:srgbClr val="000000"/>
                    </a:solidFill>
                    <a:latin typeface="Arial"/>
                  </a:rPr>
                  <a:t>B)</a:t>
                </a:r>
                <a:endParaRPr b="0" lang="en-US" sz="3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56" name=""/>
            <p:cNvGrpSpPr/>
            <p:nvPr/>
          </p:nvGrpSpPr>
          <p:grpSpPr>
            <a:xfrm>
              <a:off x="207360" y="237960"/>
              <a:ext cx="5686560" cy="4983840"/>
              <a:chOff x="207360" y="237960"/>
              <a:chExt cx="5686560" cy="4983840"/>
            </a:xfrm>
          </p:grpSpPr>
          <p:sp>
            <p:nvSpPr>
              <p:cNvPr id="57" name=""/>
              <p:cNvSpPr/>
              <p:nvPr/>
            </p:nvSpPr>
            <p:spPr>
              <a:xfrm>
                <a:off x="2039760" y="782640"/>
                <a:ext cx="1346400" cy="3144600"/>
              </a:xfrm>
              <a:custGeom>
                <a:avLst/>
                <a:gdLst/>
                <a:ahLst/>
                <a:rect l="l" t="t" r="r" b="b"/>
                <a:pathLst>
                  <a:path w="148" h="342">
                    <a:moveTo>
                      <a:pt x="0" y="0"/>
                    </a:moveTo>
                    <a:lnTo>
                      <a:pt x="49" y="114"/>
                    </a:lnTo>
                    <a:lnTo>
                      <a:pt x="98" y="228"/>
                    </a:lnTo>
                    <a:lnTo>
                      <a:pt x="148" y="342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>
                <a:off x="207360" y="237960"/>
                <a:ext cx="610560" cy="581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3200" spc="-1" strike="noStrike">
                    <a:solidFill>
                      <a:srgbClr val="000000"/>
                    </a:solidFill>
                    <a:latin typeface="Arial"/>
                  </a:rPr>
                  <a:t>A)</a:t>
                </a:r>
                <a:endParaRPr b="0" lang="en-US" sz="3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2101680" y="4886280"/>
                <a:ext cx="2468160" cy="335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200" spc="-1" strike="noStrike">
                    <a:solidFill>
                      <a:srgbClr val="000000"/>
                    </a:solidFill>
                    <a:latin typeface="Arial"/>
                  </a:rPr>
                  <a:t>Time in AmD (min)</a:t>
                </a:r>
                <a:endParaRPr b="0" lang="en-US" sz="2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 rot="16200000">
                <a:off x="-711000" y="2263680"/>
                <a:ext cx="3323160" cy="335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200" spc="-1" strike="noStrike">
                    <a:solidFill>
                      <a:srgbClr val="000000"/>
                    </a:solidFill>
                    <a:latin typeface="Arial"/>
                  </a:rPr>
                  <a:t>Transcript molecules (%)</a:t>
                </a:r>
                <a:endParaRPr b="0" lang="en-US" sz="2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1166760" y="3998880"/>
                <a:ext cx="44424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Arial"/>
                  </a:rPr>
                  <a:t>0.01</a:t>
                </a:r>
                <a:endParaRPr b="0" lang="en-US" sz="1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>
                <a:off x="1744560" y="779400"/>
                <a:ext cx="1440" cy="336528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1674720" y="4127400"/>
                <a:ext cx="71280" cy="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>
                <a:off x="1674720" y="3871800"/>
                <a:ext cx="71280" cy="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>
                <a:off x="1674720" y="3728880"/>
                <a:ext cx="71280" cy="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1674720" y="3617640"/>
                <a:ext cx="71280" cy="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>
                <a:off x="1674720" y="3538440"/>
                <a:ext cx="71280" cy="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>
                <a:off x="1674720" y="3474720"/>
                <a:ext cx="71280" cy="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1674720" y="3427200"/>
                <a:ext cx="71280" cy="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1674720" y="3379680"/>
                <a:ext cx="71280" cy="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1674720" y="3325680"/>
                <a:ext cx="71280" cy="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1674720" y="3284280"/>
                <a:ext cx="71280" cy="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1674720" y="3046320"/>
                <a:ext cx="71280" cy="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1674720" y="2887560"/>
                <a:ext cx="71280" cy="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1674720" y="2792160"/>
                <a:ext cx="71280" cy="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>
                <a:off x="1674720" y="2712960"/>
                <a:ext cx="71280" cy="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>
                <a:off x="1674720" y="2649240"/>
                <a:ext cx="71280" cy="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1674720" y="2585880"/>
                <a:ext cx="71280" cy="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>
                <a:off x="1674720" y="2538360"/>
                <a:ext cx="71280" cy="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>
                <a:off x="1674720" y="2490480"/>
                <a:ext cx="71280" cy="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>
                <a:off x="1674720" y="2458800"/>
                <a:ext cx="71280" cy="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>
                <a:off x="1674720" y="2203200"/>
                <a:ext cx="71280" cy="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>
                <a:off x="1674720" y="2060280"/>
                <a:ext cx="71280" cy="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>
                <a:off x="1674720" y="1949400"/>
                <a:ext cx="71280" cy="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>
                <a:off x="1674720" y="1869840"/>
                <a:ext cx="71280" cy="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>
                <a:off x="1674720" y="1806480"/>
                <a:ext cx="71280" cy="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>
                <a:off x="1674720" y="1758960"/>
                <a:ext cx="71280" cy="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8" name=""/>
              <p:cNvSpPr/>
              <p:nvPr/>
            </p:nvSpPr>
            <p:spPr>
              <a:xfrm>
                <a:off x="1674720" y="1711080"/>
                <a:ext cx="71280" cy="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>
                <a:off x="1674720" y="1663560"/>
                <a:ext cx="71280" cy="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>
                <a:off x="1674720" y="1377720"/>
                <a:ext cx="71280" cy="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>
                <a:off x="1674720" y="1218960"/>
                <a:ext cx="71280" cy="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>
                <a:off x="1674720" y="1123920"/>
                <a:ext cx="71280" cy="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1674720" y="1044360"/>
                <a:ext cx="71280" cy="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>
                <a:off x="1674720" y="981000"/>
                <a:ext cx="71280" cy="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>
                <a:off x="1674720" y="917280"/>
                <a:ext cx="71280" cy="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>
                <a:off x="1674720" y="869760"/>
                <a:ext cx="71280" cy="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7" name=""/>
              <p:cNvSpPr/>
              <p:nvPr/>
            </p:nvSpPr>
            <p:spPr>
              <a:xfrm>
                <a:off x="1674720" y="820440"/>
                <a:ext cx="71280" cy="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>
                <a:off x="1674720" y="788760"/>
                <a:ext cx="71280" cy="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>
                <a:off x="1674720" y="4133520"/>
                <a:ext cx="71280" cy="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>
                <a:off x="1674720" y="2458800"/>
                <a:ext cx="71280" cy="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>
                <a:off x="1674720" y="1631880"/>
                <a:ext cx="71280" cy="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>
                <a:off x="1674720" y="788760"/>
                <a:ext cx="71280" cy="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3" name=""/>
              <p:cNvSpPr/>
              <p:nvPr/>
            </p:nvSpPr>
            <p:spPr>
              <a:xfrm>
                <a:off x="1271520" y="3165480"/>
                <a:ext cx="31788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Arial"/>
                  </a:rPr>
                  <a:t>0.1</a:t>
                </a:r>
                <a:endParaRPr b="0" lang="en-US" sz="1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4" name=""/>
              <p:cNvSpPr/>
              <p:nvPr/>
            </p:nvSpPr>
            <p:spPr>
              <a:xfrm>
                <a:off x="1428480" y="2368440"/>
                <a:ext cx="12708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1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>
                <a:off x="1323720" y="1496880"/>
                <a:ext cx="25380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endParaRPr b="0" lang="en-US" sz="1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6" name=""/>
              <p:cNvSpPr/>
              <p:nvPr/>
            </p:nvSpPr>
            <p:spPr>
              <a:xfrm>
                <a:off x="1219320" y="682560"/>
                <a:ext cx="38016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Arial"/>
                  </a:rPr>
                  <a:t>100</a:t>
                </a:r>
                <a:endParaRPr b="0" lang="en-US" sz="1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7" name=""/>
              <p:cNvSpPr/>
              <p:nvPr/>
            </p:nvSpPr>
            <p:spPr>
              <a:xfrm>
                <a:off x="2038320" y="4319280"/>
                <a:ext cx="2687400" cy="180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8" name=""/>
              <p:cNvSpPr/>
              <p:nvPr/>
            </p:nvSpPr>
            <p:spPr>
              <a:xfrm flipV="1">
                <a:off x="2047680" y="4314240"/>
                <a:ext cx="3240" cy="7164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840" bIns="248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9" name=""/>
              <p:cNvSpPr/>
              <p:nvPr/>
            </p:nvSpPr>
            <p:spPr>
              <a:xfrm flipV="1">
                <a:off x="3381120" y="4314240"/>
                <a:ext cx="3240" cy="7164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840" bIns="248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 flipV="1">
                <a:off x="4725720" y="4314240"/>
                <a:ext cx="1800" cy="7164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840" bIns="248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 flipV="1">
                <a:off x="2709720" y="4314240"/>
                <a:ext cx="3240" cy="7164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840" bIns="248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 flipV="1">
                <a:off x="4052880" y="4314240"/>
                <a:ext cx="2880" cy="7164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840" bIns="248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3" name=""/>
              <p:cNvSpPr/>
              <p:nvPr/>
            </p:nvSpPr>
            <p:spPr>
              <a:xfrm>
                <a:off x="1971720" y="4446360"/>
                <a:ext cx="12708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>
                <a:off x="3236760" y="4446360"/>
                <a:ext cx="25380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Arial"/>
                  </a:rPr>
                  <a:t>30</a:t>
                </a:r>
                <a:endParaRPr b="0" lang="en-US" sz="1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5" name=""/>
              <p:cNvSpPr/>
              <p:nvPr/>
            </p:nvSpPr>
            <p:spPr>
              <a:xfrm>
                <a:off x="4633920" y="4446360"/>
                <a:ext cx="25380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Arial"/>
                  </a:rPr>
                  <a:t>60</a:t>
                </a:r>
                <a:endParaRPr b="0" lang="en-US" sz="1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6" name=""/>
              <p:cNvSpPr/>
              <p:nvPr/>
            </p:nvSpPr>
            <p:spPr>
              <a:xfrm>
                <a:off x="2624040" y="2782800"/>
                <a:ext cx="179280" cy="179280"/>
              </a:xfrm>
              <a:prstGeom prst="ellipse">
                <a:avLst/>
              </a:prstGeom>
              <a:solidFill>
                <a:srgbClr val="ffffff"/>
              </a:solidFill>
              <a:ln w="19080">
                <a:solidFill>
                  <a:srgbClr val="08080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>
                <a:off x="3301920" y="3490920"/>
                <a:ext cx="179280" cy="179280"/>
              </a:xfrm>
              <a:prstGeom prst="ellipse">
                <a:avLst/>
              </a:prstGeom>
              <a:solidFill>
                <a:srgbClr val="080808"/>
              </a:solidFill>
              <a:ln w="19080">
                <a:solidFill>
                  <a:srgbClr val="08080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8" name=""/>
              <p:cNvSpPr/>
              <p:nvPr/>
            </p:nvSpPr>
            <p:spPr>
              <a:xfrm>
                <a:off x="2625480" y="2920680"/>
                <a:ext cx="179640" cy="179640"/>
              </a:xfrm>
              <a:prstGeom prst="ellipse">
                <a:avLst/>
              </a:prstGeom>
              <a:solidFill>
                <a:srgbClr val="000000"/>
              </a:solidFill>
              <a:ln w="19080">
                <a:solidFill>
                  <a:srgbClr val="08080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9" name=""/>
              <p:cNvSpPr/>
              <p:nvPr/>
            </p:nvSpPr>
            <p:spPr>
              <a:xfrm>
                <a:off x="2394000" y="2228760"/>
                <a:ext cx="179280" cy="179280"/>
              </a:xfrm>
              <a:prstGeom prst="ellipse">
                <a:avLst/>
              </a:prstGeom>
              <a:solidFill>
                <a:srgbClr val="000000"/>
              </a:solidFill>
              <a:ln w="19080">
                <a:solidFill>
                  <a:srgbClr val="08080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0" name=""/>
              <p:cNvSpPr/>
              <p:nvPr/>
            </p:nvSpPr>
            <p:spPr>
              <a:xfrm>
                <a:off x="4798800" y="1569960"/>
                <a:ext cx="109512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800" spc="-1" strike="noStrike">
                    <a:solidFill>
                      <a:srgbClr val="000000"/>
                    </a:solidFill>
                    <a:latin typeface="Arial"/>
                  </a:rPr>
                  <a:t>13.6 min</a:t>
                </a:r>
                <a:endParaRPr b="0" lang="en-US" sz="1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1" name=""/>
              <p:cNvSpPr/>
              <p:nvPr/>
            </p:nvSpPr>
            <p:spPr>
              <a:xfrm>
                <a:off x="4798800" y="2027160"/>
                <a:ext cx="109512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800" spc="-1" strike="noStrike">
                    <a:solidFill>
                      <a:srgbClr val="000000"/>
                    </a:solidFill>
                    <a:latin typeface="Arial"/>
                  </a:rPr>
                  <a:t>12.0 min</a:t>
                </a:r>
                <a:endParaRPr b="0" lang="en-US" sz="1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2" name=""/>
              <p:cNvSpPr/>
              <p:nvPr/>
            </p:nvSpPr>
            <p:spPr>
              <a:xfrm>
                <a:off x="3474720" y="3022560"/>
                <a:ext cx="9687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800" spc="-1" strike="noStrike">
                    <a:solidFill>
                      <a:srgbClr val="000000"/>
                    </a:solidFill>
                    <a:latin typeface="Arial"/>
                  </a:rPr>
                  <a:t>2.3 min</a:t>
                </a:r>
                <a:endParaRPr b="0" lang="en-US" sz="1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3" name=""/>
              <p:cNvSpPr/>
              <p:nvPr/>
            </p:nvSpPr>
            <p:spPr>
              <a:xfrm>
                <a:off x="3474720" y="3371760"/>
                <a:ext cx="9687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800" spc="-1" strike="noStrike">
                    <a:solidFill>
                      <a:srgbClr val="000000"/>
                    </a:solidFill>
                    <a:latin typeface="Arial"/>
                  </a:rPr>
                  <a:t>2.2 min</a:t>
                </a:r>
                <a:endParaRPr b="0" lang="en-US" sz="1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4" name=""/>
              <p:cNvSpPr/>
              <p:nvPr/>
            </p:nvSpPr>
            <p:spPr>
              <a:xfrm>
                <a:off x="4624200" y="1966680"/>
                <a:ext cx="179280" cy="179280"/>
              </a:xfrm>
              <a:prstGeom prst="triangle">
                <a:avLst>
                  <a:gd name="adj" fmla="val 50000"/>
                </a:avLst>
              </a:prstGeom>
              <a:solidFill>
                <a:srgbClr val="000000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12960" bIns="12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5" name=""/>
              <p:cNvSpPr/>
              <p:nvPr/>
            </p:nvSpPr>
            <p:spPr>
              <a:xfrm>
                <a:off x="2392200" y="2598480"/>
                <a:ext cx="179280" cy="179640"/>
              </a:xfrm>
              <a:prstGeom prst="ellipse">
                <a:avLst/>
              </a:prstGeom>
              <a:solidFill>
                <a:srgbClr val="ffffff"/>
              </a:solidFill>
              <a:ln w="19080">
                <a:solidFill>
                  <a:srgbClr val="08080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6" name=""/>
              <p:cNvSpPr/>
              <p:nvPr/>
            </p:nvSpPr>
            <p:spPr>
              <a:xfrm>
                <a:off x="2044440" y="796680"/>
                <a:ext cx="2683080" cy="1243080"/>
              </a:xfrm>
              <a:custGeom>
                <a:avLst/>
                <a:gdLst/>
                <a:ahLst/>
                <a:rect l="l" t="t" r="r" b="b"/>
                <a:pathLst>
                  <a:path w="295" h="131">
                    <a:moveTo>
                      <a:pt x="0" y="0"/>
                    </a:moveTo>
                    <a:lnTo>
                      <a:pt x="74" y="33"/>
                    </a:lnTo>
                    <a:lnTo>
                      <a:pt x="148" y="66"/>
                    </a:lnTo>
                    <a:lnTo>
                      <a:pt x="221" y="99"/>
                    </a:lnTo>
                    <a:lnTo>
                      <a:pt x="295" y="131"/>
                    </a:lnTo>
                  </a:path>
                </a:pathLst>
              </a:custGeom>
              <a:noFill/>
              <a:ln w="19080">
                <a:solidFill>
                  <a:srgbClr val="ff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7" name=""/>
              <p:cNvSpPr/>
              <p:nvPr/>
            </p:nvSpPr>
            <p:spPr>
              <a:xfrm>
                <a:off x="2044440" y="796680"/>
                <a:ext cx="2683080" cy="1243080"/>
              </a:xfrm>
              <a:custGeom>
                <a:avLst/>
                <a:gdLst/>
                <a:ahLst/>
                <a:rect l="l" t="t" r="r" b="b"/>
                <a:pathLst>
                  <a:path w="295" h="131">
                    <a:moveTo>
                      <a:pt x="0" y="0"/>
                    </a:moveTo>
                    <a:lnTo>
                      <a:pt x="74" y="33"/>
                    </a:lnTo>
                    <a:lnTo>
                      <a:pt x="148" y="66"/>
                    </a:lnTo>
                    <a:lnTo>
                      <a:pt x="221" y="99"/>
                    </a:lnTo>
                    <a:lnTo>
                      <a:pt x="295" y="131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8" name=""/>
              <p:cNvSpPr/>
              <p:nvPr/>
            </p:nvSpPr>
            <p:spPr>
              <a:xfrm>
                <a:off x="2044440" y="796680"/>
                <a:ext cx="2683080" cy="1109880"/>
              </a:xfrm>
              <a:custGeom>
                <a:avLst/>
                <a:gdLst/>
                <a:ahLst/>
                <a:rect l="l" t="t" r="r" b="b"/>
                <a:pathLst>
                  <a:path w="295" h="117">
                    <a:moveTo>
                      <a:pt x="0" y="0"/>
                    </a:moveTo>
                    <a:lnTo>
                      <a:pt x="74" y="29"/>
                    </a:lnTo>
                    <a:lnTo>
                      <a:pt x="148" y="58"/>
                    </a:lnTo>
                    <a:lnTo>
                      <a:pt x="221" y="88"/>
                    </a:lnTo>
                    <a:lnTo>
                      <a:pt x="295" y="117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9" name=""/>
              <p:cNvSpPr/>
              <p:nvPr/>
            </p:nvSpPr>
            <p:spPr>
              <a:xfrm>
                <a:off x="2044440" y="796680"/>
                <a:ext cx="1346400" cy="3245040"/>
              </a:xfrm>
              <a:custGeom>
                <a:avLst/>
                <a:gdLst/>
                <a:ahLst/>
                <a:rect l="l" t="t" r="r" b="b"/>
                <a:pathLst>
                  <a:path w="148" h="342">
                    <a:moveTo>
                      <a:pt x="0" y="0"/>
                    </a:moveTo>
                    <a:lnTo>
                      <a:pt x="49" y="114"/>
                    </a:lnTo>
                    <a:lnTo>
                      <a:pt x="98" y="228"/>
                    </a:lnTo>
                    <a:lnTo>
                      <a:pt x="148" y="342"/>
                    </a:lnTo>
                  </a:path>
                </a:pathLst>
              </a:custGeom>
              <a:noFill/>
              <a:ln w="1908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0" name=""/>
              <p:cNvSpPr/>
              <p:nvPr/>
            </p:nvSpPr>
            <p:spPr>
              <a:xfrm>
                <a:off x="2044440" y="796680"/>
                <a:ext cx="1346400" cy="3235320"/>
              </a:xfrm>
              <a:custGeom>
                <a:avLst/>
                <a:gdLst/>
                <a:ahLst/>
                <a:rect l="l" t="t" r="r" b="b"/>
                <a:pathLst>
                  <a:path w="148" h="341">
                    <a:moveTo>
                      <a:pt x="0" y="0"/>
                    </a:moveTo>
                    <a:lnTo>
                      <a:pt x="49" y="114"/>
                    </a:lnTo>
                    <a:lnTo>
                      <a:pt x="98" y="228"/>
                    </a:lnTo>
                    <a:lnTo>
                      <a:pt x="148" y="341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1" name=""/>
              <p:cNvSpPr/>
              <p:nvPr/>
            </p:nvSpPr>
            <p:spPr>
              <a:xfrm>
                <a:off x="2044440" y="796680"/>
                <a:ext cx="2683080" cy="1243080"/>
              </a:xfrm>
              <a:custGeom>
                <a:avLst/>
                <a:gdLst/>
                <a:ahLst/>
                <a:rect l="l" t="t" r="r" b="b"/>
                <a:pathLst>
                  <a:path w="295" h="131">
                    <a:moveTo>
                      <a:pt x="0" y="0"/>
                    </a:moveTo>
                    <a:lnTo>
                      <a:pt x="74" y="33"/>
                    </a:lnTo>
                    <a:lnTo>
                      <a:pt x="148" y="66"/>
                    </a:lnTo>
                    <a:lnTo>
                      <a:pt x="221" y="99"/>
                    </a:lnTo>
                    <a:lnTo>
                      <a:pt x="295" y="131"/>
                    </a:lnTo>
                  </a:path>
                </a:pathLst>
              </a:custGeom>
              <a:noFill/>
              <a:ln w="19080">
                <a:solidFill>
                  <a:srgbClr val="ff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>
                <a:off x="2044440" y="796680"/>
                <a:ext cx="2683080" cy="1243080"/>
              </a:xfrm>
              <a:custGeom>
                <a:avLst/>
                <a:gdLst/>
                <a:ahLst/>
                <a:rect l="l" t="t" r="r" b="b"/>
                <a:pathLst>
                  <a:path w="295" h="131">
                    <a:moveTo>
                      <a:pt x="0" y="0"/>
                    </a:moveTo>
                    <a:lnTo>
                      <a:pt x="74" y="33"/>
                    </a:lnTo>
                    <a:lnTo>
                      <a:pt x="148" y="66"/>
                    </a:lnTo>
                    <a:lnTo>
                      <a:pt x="221" y="99"/>
                    </a:lnTo>
                    <a:lnTo>
                      <a:pt x="295" y="131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3" name=""/>
              <p:cNvSpPr/>
              <p:nvPr/>
            </p:nvSpPr>
            <p:spPr>
              <a:xfrm>
                <a:off x="2044440" y="796680"/>
                <a:ext cx="2683080" cy="1109880"/>
              </a:xfrm>
              <a:custGeom>
                <a:avLst/>
                <a:gdLst/>
                <a:ahLst/>
                <a:rect l="l" t="t" r="r" b="b"/>
                <a:pathLst>
                  <a:path w="295" h="117">
                    <a:moveTo>
                      <a:pt x="0" y="0"/>
                    </a:moveTo>
                    <a:lnTo>
                      <a:pt x="74" y="29"/>
                    </a:lnTo>
                    <a:lnTo>
                      <a:pt x="148" y="58"/>
                    </a:lnTo>
                    <a:lnTo>
                      <a:pt x="221" y="88"/>
                    </a:lnTo>
                    <a:lnTo>
                      <a:pt x="295" y="117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4" name=""/>
              <p:cNvSpPr/>
              <p:nvPr/>
            </p:nvSpPr>
            <p:spPr>
              <a:xfrm>
                <a:off x="2044440" y="796680"/>
                <a:ext cx="1346400" cy="3245040"/>
              </a:xfrm>
              <a:custGeom>
                <a:avLst/>
                <a:gdLst/>
                <a:ahLst/>
                <a:rect l="l" t="t" r="r" b="b"/>
                <a:pathLst>
                  <a:path w="148" h="342">
                    <a:moveTo>
                      <a:pt x="0" y="0"/>
                    </a:moveTo>
                    <a:lnTo>
                      <a:pt x="49" y="114"/>
                    </a:lnTo>
                    <a:lnTo>
                      <a:pt x="98" y="228"/>
                    </a:lnTo>
                    <a:lnTo>
                      <a:pt x="148" y="342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5" name=""/>
              <p:cNvSpPr/>
              <p:nvPr/>
            </p:nvSpPr>
            <p:spPr>
              <a:xfrm>
                <a:off x="2398680" y="1029960"/>
                <a:ext cx="179280" cy="179640"/>
              </a:xfrm>
              <a:prstGeom prst="triangle">
                <a:avLst>
                  <a:gd name="adj" fmla="val 50000"/>
                </a:avLst>
              </a:prstGeom>
              <a:solidFill>
                <a:srgbClr val="000000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12960" bIns="12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6" name=""/>
              <p:cNvSpPr/>
              <p:nvPr/>
            </p:nvSpPr>
            <p:spPr>
              <a:xfrm>
                <a:off x="3303360" y="3479760"/>
                <a:ext cx="179640" cy="179280"/>
              </a:xfrm>
              <a:prstGeom prst="ellipse">
                <a:avLst/>
              </a:prstGeom>
              <a:solidFill>
                <a:srgbClr val="ffffff"/>
              </a:solidFill>
              <a:ln w="19080">
                <a:solidFill>
                  <a:srgbClr val="08080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7" name=""/>
              <p:cNvSpPr/>
              <p:nvPr/>
            </p:nvSpPr>
            <p:spPr>
              <a:xfrm>
                <a:off x="4632120" y="1739880"/>
                <a:ext cx="179640" cy="179280"/>
              </a:xfrm>
              <a:prstGeom prst="triangle">
                <a:avLst>
                  <a:gd name="adj" fmla="val 50000"/>
                </a:avLst>
              </a:prstGeom>
              <a:solidFill>
                <a:srgbClr val="ffffff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12960" bIns="12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8" name=""/>
              <p:cNvSpPr/>
              <p:nvPr/>
            </p:nvSpPr>
            <p:spPr>
              <a:xfrm>
                <a:off x="3289320" y="1190520"/>
                <a:ext cx="179280" cy="179280"/>
              </a:xfrm>
              <a:prstGeom prst="triangle">
                <a:avLst>
                  <a:gd name="adj" fmla="val 50000"/>
                </a:avLst>
              </a:prstGeom>
              <a:solidFill>
                <a:srgbClr val="ffffff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12960" bIns="12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9" name=""/>
              <p:cNvSpPr/>
              <p:nvPr/>
            </p:nvSpPr>
            <p:spPr>
              <a:xfrm>
                <a:off x="2617560" y="928440"/>
                <a:ext cx="179640" cy="179640"/>
              </a:xfrm>
              <a:prstGeom prst="triangle">
                <a:avLst>
                  <a:gd name="adj" fmla="val 50000"/>
                </a:avLst>
              </a:prstGeom>
              <a:solidFill>
                <a:srgbClr val="000000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12960" bIns="12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0" name=""/>
              <p:cNvSpPr/>
              <p:nvPr/>
            </p:nvSpPr>
            <p:spPr>
              <a:xfrm>
                <a:off x="2620800" y="1058760"/>
                <a:ext cx="179280" cy="179280"/>
              </a:xfrm>
              <a:prstGeom prst="triangle">
                <a:avLst>
                  <a:gd name="adj" fmla="val 50000"/>
                </a:avLst>
              </a:prstGeom>
              <a:solidFill>
                <a:srgbClr val="ffffff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12960" bIns="12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1" name=""/>
              <p:cNvSpPr/>
              <p:nvPr/>
            </p:nvSpPr>
            <p:spPr>
              <a:xfrm>
                <a:off x="3286080" y="1315800"/>
                <a:ext cx="179280" cy="179280"/>
              </a:xfrm>
              <a:prstGeom prst="triangle">
                <a:avLst>
                  <a:gd name="adj" fmla="val 50000"/>
                </a:avLst>
              </a:prstGeom>
              <a:solidFill>
                <a:srgbClr val="000000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12960" bIns="12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2" name=""/>
              <p:cNvSpPr/>
              <p:nvPr/>
            </p:nvSpPr>
            <p:spPr>
              <a:xfrm>
                <a:off x="1933560" y="712800"/>
                <a:ext cx="179280" cy="179280"/>
              </a:xfrm>
              <a:prstGeom prst="ellipse">
                <a:avLst/>
              </a:prstGeom>
              <a:solidFill>
                <a:srgbClr val="c0c0c0"/>
              </a:solidFill>
              <a:ln w="19080">
                <a:solidFill>
                  <a:srgbClr val="08080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3" name=""/>
              <p:cNvSpPr/>
              <p:nvPr/>
            </p:nvSpPr>
            <p:spPr>
              <a:xfrm>
                <a:off x="1933560" y="699840"/>
                <a:ext cx="179280" cy="179640"/>
              </a:xfrm>
              <a:prstGeom prst="triangle">
                <a:avLst>
                  <a:gd name="adj" fmla="val 50000"/>
                </a:avLst>
              </a:prstGeom>
              <a:solidFill>
                <a:srgbClr val="c0c0c0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12960" bIns="12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9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4-09-29T13:59:32Z</dcterms:created>
  <dc:creator>The MacOS X is…</dc:creator>
  <dc:description/>
  <dc:language>en-US</dc:language>
  <cp:lastModifiedBy>.</cp:lastModifiedBy>
  <cp:lastPrinted>2006-12-04T12:03:32Z</cp:lastPrinted>
  <dcterms:modified xsi:type="dcterms:W3CDTF">2007-08-07T08:26:38Z</dcterms:modified>
  <cp:revision>57</cp:revision>
  <dc:subject/>
  <dc:title>No Slide Title</dc:title>
</cp:coreProperties>
</file>